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3473DFF-6565-426B-81CB-F8EA3CEB3B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A038114-D380-4018-83EA-508AD05BAE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C08F57F-C5C2-4C21-AC64-8726EA0A6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87D4599-1699-4E95-BEE7-99067C0BB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FADD8AF-F65B-403B-B29A-523440D8E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6221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60DDD7-85D7-4D95-83E3-1862AD1843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60BEEB9-8C5A-467C-988D-B6CB6B66A1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156AA8B-69D6-4198-8F6E-1E61B4C90D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6ABC534-D3D6-4194-8645-BCF7BDBB2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1D5281A-31DE-4CC1-89DE-27B64DC34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2089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797866D-88B8-4EBA-9C89-C772067C97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A186E7F-CE7B-4730-8CEF-EAECA2F55C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FE8387D-9F2F-4582-B2F3-362FB8731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24D923E-ABEF-411F-AB52-37069A219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ADE845A-A100-42AD-9F3C-76C409068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0661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0CFB9EA-8EC5-42CF-82D4-7D32D85550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5F21CF3-6E3D-4A67-BD74-BEFA1FD2A4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E2EE5AA-BA39-42E9-8BB5-15F83B29B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096DFD6-EE59-4301-89C3-B11E16F9A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17DAB75-908C-4F84-8299-EBE5BE15C9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6745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040718-D9FC-4FCC-B1F2-C50657DAAF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5647E00-0C80-4C9C-9D2A-32464A6538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261A8C2-B0B4-4B39-AEAF-0D6F57545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EE31810-BAD8-4995-BC28-44A10AF20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28CD5AE-AFE3-4181-BA1C-6FD3927F2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4829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245AAE-F794-4130-8A4E-439B0D06D8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1FC3843-D591-46B2-98C3-91921647F6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77B7A9F-1F0F-401E-9758-791E523111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BF1D261-034C-4941-BAA9-DBD178D5E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3FF069E-4FCD-45F7-B9CE-BF6A29A65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EFE937C-3051-495A-8F78-03A4CA0CA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5755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8476E58-58F9-4AFE-BEF2-23CB3346AA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7C90713-AB24-4162-84B9-6F36CBE617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F606609-2818-4BA5-ABC4-A9258EE859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299818C9-8F48-4A3F-B901-9B1D9CB0BA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EE35761-BD94-486A-BF3A-7CB58CC4BF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790034E7-FDDF-467C-83B2-FC5F9545F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437CDFDB-921B-44C4-BDB4-84B6F4EED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4B87C20-DD26-46C0-9BF7-F980AD802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3747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8580F1-5134-440C-BC61-EE602BE770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A007F184-E195-42AD-A31D-AA96E6FC9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28DBA0C-C1FE-4E1B-B83C-7A81B30C5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828A75D-5016-4CBB-9E63-5DA74EF7F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3700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320287C-1558-48FE-B6E4-8CBC6F267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87E889D-970C-4096-AA15-8C1669AB5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1956636-8CAC-483C-9D5B-5A83DFF0A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5485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1B74910-E53F-49FC-988B-ACB654B14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AFC3DF4-D33F-4E4C-B94A-702CC0B9E0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5274565-9B99-405E-8DA1-7E2458B4B1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CF3E331-A4E4-4673-B7E6-0F9E55358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9B0744F-5391-4D52-A566-E5CD63928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4A1605A-0EC7-43E8-9084-E2CADF7A9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0530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1533C23-1570-4767-ADE2-64013A770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BB4D8BC-4982-412F-8B20-FDD4DB3580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772F5F3-18C6-4F3D-9080-88F9376168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5B74F95-8162-486B-BCF3-842965129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FBB13EB-8FE1-44E3-B9E7-5B3A44B82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8EE1C11-0A62-428B-9619-2AA6C6947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9559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E5C68B56-B7E0-4A60-BB37-B0349BC0F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40D4C88-B8D6-4620-A01D-A60BA13924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E1A3144-A96B-4D5F-A915-96AAE2566C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F71B03-960F-4CF0-A5D4-A61DF20E115C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49C4E62-D180-45D8-B9E9-64B9426C66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6E77DD0-5903-462E-A751-B47D49810B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22A75-2815-4336-BDDB-4011DB9214E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668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el 1">
            <a:extLst>
              <a:ext uri="{FF2B5EF4-FFF2-40B4-BE49-F238E27FC236}">
                <a16:creationId xmlns:a16="http://schemas.microsoft.com/office/drawing/2014/main" id="{35563FB4-18EA-43AB-914F-280E4AE31A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078" y="200870"/>
            <a:ext cx="12163921" cy="365163"/>
          </a:xfrm>
        </p:spPr>
        <p:txBody>
          <a:bodyPr>
            <a:noAutofit/>
          </a:bodyPr>
          <a:lstStyle/>
          <a:p>
            <a:r>
              <a:rPr lang="de-DE" sz="1400" b="1" dirty="0" err="1"/>
              <a:t>Supplemental</a:t>
            </a:r>
            <a:r>
              <a:rPr lang="de-DE" sz="1400" b="1" dirty="0"/>
              <a:t> Figure</a:t>
            </a:r>
            <a:r>
              <a:rPr lang="de-DE" sz="1400" dirty="0"/>
              <a:t> </a:t>
            </a:r>
            <a:r>
              <a:rPr lang="de-DE" sz="1400" b="1" dirty="0"/>
              <a:t>1</a:t>
            </a:r>
            <a:r>
              <a:rPr lang="de-DE" sz="1400" dirty="0"/>
              <a:t>: </a:t>
            </a:r>
            <a:r>
              <a:rPr lang="en-US" sz="1400" dirty="0">
                <a:effectLst/>
                <a:ea typeface="Calibri" panose="020F0502020204030204" pitchFamily="34" charset="0"/>
              </a:rPr>
              <a:t>Progression-free survival for all patients with early stages (A), for the comparison GP AB </a:t>
            </a:r>
            <a:r>
              <a:rPr lang="en-US" sz="1400" i="1" dirty="0">
                <a:effectLst/>
                <a:ea typeface="Calibri" panose="020F0502020204030204" pitchFamily="34" charset="0"/>
              </a:rPr>
              <a:t>vs</a:t>
            </a:r>
            <a:r>
              <a:rPr lang="en-US" sz="1400" dirty="0">
                <a:effectLst/>
                <a:ea typeface="Calibri" panose="020F0502020204030204" pitchFamily="34" charset="0"/>
              </a:rPr>
              <a:t> CDEF in early-stage patients (B), for the comparison GP ABC </a:t>
            </a:r>
            <a:r>
              <a:rPr lang="en-US" sz="1400" i="1" dirty="0">
                <a:effectLst/>
                <a:ea typeface="Calibri" panose="020F0502020204030204" pitchFamily="34" charset="0"/>
              </a:rPr>
              <a:t>vs</a:t>
            </a:r>
            <a:r>
              <a:rPr lang="en-US" sz="1400" dirty="0">
                <a:effectLst/>
                <a:ea typeface="Calibri" panose="020F0502020204030204" pitchFamily="34" charset="0"/>
              </a:rPr>
              <a:t> DEF in early-stage patients (C) and for the comparison GP ABCF </a:t>
            </a:r>
            <a:r>
              <a:rPr lang="en-US" sz="1400" i="1" dirty="0">
                <a:effectLst/>
                <a:ea typeface="Calibri" panose="020F0502020204030204" pitchFamily="34" charset="0"/>
              </a:rPr>
              <a:t>vs</a:t>
            </a:r>
            <a:r>
              <a:rPr lang="en-US" sz="1400" dirty="0">
                <a:effectLst/>
                <a:ea typeface="Calibri" panose="020F0502020204030204" pitchFamily="34" charset="0"/>
              </a:rPr>
              <a:t> DE in early-stage patients (D)</a:t>
            </a:r>
            <a:br>
              <a:rPr lang="de-DE" sz="1400" dirty="0">
                <a:effectLst/>
                <a:ea typeface="Calibri" panose="020F0502020204030204" pitchFamily="34" charset="0"/>
              </a:rPr>
            </a:br>
            <a:endParaRPr lang="en-US" sz="1400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232B8A56-0F39-4AF2-A20E-7A067B20E80C}"/>
              </a:ext>
            </a:extLst>
          </p:cNvPr>
          <p:cNvSpPr txBox="1"/>
          <p:nvPr/>
        </p:nvSpPr>
        <p:spPr>
          <a:xfrm>
            <a:off x="641684" y="914398"/>
            <a:ext cx="46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E35271B8-F75B-4D41-9230-529A441CCECA}"/>
              </a:ext>
            </a:extLst>
          </p:cNvPr>
          <p:cNvSpPr txBox="1"/>
          <p:nvPr/>
        </p:nvSpPr>
        <p:spPr>
          <a:xfrm>
            <a:off x="6336649" y="914398"/>
            <a:ext cx="46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EF22F2F1-EC3C-4E96-8541-FED2F154BB6E}"/>
              </a:ext>
            </a:extLst>
          </p:cNvPr>
          <p:cNvSpPr txBox="1"/>
          <p:nvPr/>
        </p:nvSpPr>
        <p:spPr>
          <a:xfrm>
            <a:off x="641684" y="4002506"/>
            <a:ext cx="46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C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E7D7691A-5698-4910-B702-42C4D5D5D721}"/>
              </a:ext>
            </a:extLst>
          </p:cNvPr>
          <p:cNvSpPr txBox="1"/>
          <p:nvPr/>
        </p:nvSpPr>
        <p:spPr>
          <a:xfrm>
            <a:off x="6328632" y="3994487"/>
            <a:ext cx="46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D</a:t>
            </a:r>
          </a:p>
        </p:txBody>
      </p:sp>
      <p:pic>
        <p:nvPicPr>
          <p:cNvPr id="18" name="Grafik 17">
            <a:extLst>
              <a:ext uri="{FF2B5EF4-FFF2-40B4-BE49-F238E27FC236}">
                <a16:creationId xmlns:a16="http://schemas.microsoft.com/office/drawing/2014/main" id="{DFE8569F-465C-49A3-8DF7-E4B66C45F8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8359" y="641692"/>
            <a:ext cx="4956994" cy="3009138"/>
          </a:xfrm>
          <a:prstGeom prst="rect">
            <a:avLst/>
          </a:prstGeom>
        </p:spPr>
      </p:pic>
      <p:sp>
        <p:nvSpPr>
          <p:cNvPr id="19" name="Textplatzhalter 3">
            <a:extLst>
              <a:ext uri="{FF2B5EF4-FFF2-40B4-BE49-F238E27FC236}">
                <a16:creationId xmlns:a16="http://schemas.microsoft.com/office/drawing/2014/main" id="{DBE7FE86-5009-4F8E-8C87-00414FE672C3}"/>
              </a:ext>
            </a:extLst>
          </p:cNvPr>
          <p:cNvSpPr txBox="1">
            <a:spLocks/>
          </p:cNvSpPr>
          <p:nvPr/>
        </p:nvSpPr>
        <p:spPr>
          <a:xfrm>
            <a:off x="1398857" y="1621392"/>
            <a:ext cx="2579586" cy="7080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ctr" defTabSz="9144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de-DE" sz="1000" dirty="0">
                <a:solidFill>
                  <a:srgbClr val="0070C0"/>
                </a:solidFill>
              </a:rPr>
              <a:t>5-year PFS 88.4% (95% CI 85.2-91.6)</a:t>
            </a:r>
          </a:p>
          <a:p>
            <a:pPr algn="l"/>
            <a:r>
              <a:rPr lang="de-DE" sz="1000" dirty="0">
                <a:solidFill>
                  <a:srgbClr val="0070C0"/>
                </a:solidFill>
              </a:rPr>
              <a:t>10-year PFS 80.5% (95% CI 75.2-85.7)</a:t>
            </a:r>
          </a:p>
        </p:txBody>
      </p:sp>
      <p:pic>
        <p:nvPicPr>
          <p:cNvPr id="20" name="Grafik 19">
            <a:extLst>
              <a:ext uri="{FF2B5EF4-FFF2-40B4-BE49-F238E27FC236}">
                <a16:creationId xmlns:a16="http://schemas.microsoft.com/office/drawing/2014/main" id="{96C3FAC3-5514-4CD2-A20F-F111EA7E19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5697" y="641692"/>
            <a:ext cx="4844725" cy="3152266"/>
          </a:xfrm>
          <a:prstGeom prst="rect">
            <a:avLst/>
          </a:prstGeom>
        </p:spPr>
      </p:pic>
      <p:sp>
        <p:nvSpPr>
          <p:cNvPr id="21" name="Textplatzhalter 3">
            <a:extLst>
              <a:ext uri="{FF2B5EF4-FFF2-40B4-BE49-F238E27FC236}">
                <a16:creationId xmlns:a16="http://schemas.microsoft.com/office/drawing/2014/main" id="{63103005-208B-49AD-94FA-AB266A2736F4}"/>
              </a:ext>
            </a:extLst>
          </p:cNvPr>
          <p:cNvSpPr txBox="1">
            <a:spLocks/>
          </p:cNvSpPr>
          <p:nvPr/>
        </p:nvSpPr>
        <p:spPr>
          <a:xfrm>
            <a:off x="7224904" y="1621217"/>
            <a:ext cx="2657042" cy="1635334"/>
          </a:xfrm>
          <a:prstGeom prst="rect">
            <a:avLst/>
          </a:prstGeom>
        </p:spPr>
        <p:txBody>
          <a:bodyPr vert="horz" lIns="36000" tIns="0" rIns="0" bIns="0" rtlCol="0">
            <a:noAutofit/>
          </a:bodyPr>
          <a:lstStyle>
            <a:lvl1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1pPr>
            <a:lvl2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2pPr>
            <a:lvl3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3pPr>
            <a:lvl4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4pPr>
            <a:lvl5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5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5-year PFS 89.4% (95% CI 85.8-92.9)</a:t>
            </a:r>
          </a:p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10-year PFS 80.1% (95% CI 73.9-86.3)</a:t>
            </a:r>
            <a:endParaRPr lang="en-US" sz="1000" dirty="0">
              <a:solidFill>
                <a:schemeClr val="accent2"/>
              </a:solidFill>
            </a:endParaRP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5-year PFS 85% (95% CI 77.7-92.3)</a:t>
            </a: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10-year PFS 81.3% (95% CI 71.4-91.3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None/>
            </a:pPr>
            <a:r>
              <a:rPr lang="de-DE" sz="1000" dirty="0">
                <a:solidFill>
                  <a:schemeClr val="tx1"/>
                </a:solidFill>
              </a:rPr>
              <a:t>HR = 1 (95% CI 0.5-1.7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Font typeface="Arial"/>
              <a:buNone/>
            </a:pPr>
            <a:endParaRPr lang="de-DE" sz="1000" dirty="0">
              <a:solidFill>
                <a:srgbClr val="0070C0"/>
              </a:solidFill>
            </a:endParaRPr>
          </a:p>
        </p:txBody>
      </p:sp>
      <p:pic>
        <p:nvPicPr>
          <p:cNvPr id="22" name="Grafik 21">
            <a:extLst>
              <a:ext uri="{FF2B5EF4-FFF2-40B4-BE49-F238E27FC236}">
                <a16:creationId xmlns:a16="http://schemas.microsoft.com/office/drawing/2014/main" id="{26746DB6-91C5-4168-A0A3-BF3BA44EAEB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211" y="3729800"/>
            <a:ext cx="5021158" cy="3128199"/>
          </a:xfrm>
          <a:prstGeom prst="rect">
            <a:avLst/>
          </a:prstGeom>
        </p:spPr>
      </p:pic>
      <p:sp>
        <p:nvSpPr>
          <p:cNvPr id="23" name="Textplatzhalter 3">
            <a:extLst>
              <a:ext uri="{FF2B5EF4-FFF2-40B4-BE49-F238E27FC236}">
                <a16:creationId xmlns:a16="http://schemas.microsoft.com/office/drawing/2014/main" id="{0EF9507D-C7A9-4376-B51E-ED2F09B92A80}"/>
              </a:ext>
            </a:extLst>
          </p:cNvPr>
          <p:cNvSpPr txBox="1">
            <a:spLocks/>
          </p:cNvSpPr>
          <p:nvPr/>
        </p:nvSpPr>
        <p:spPr>
          <a:xfrm>
            <a:off x="1345473" y="4703769"/>
            <a:ext cx="2897665" cy="1043038"/>
          </a:xfrm>
          <a:prstGeom prst="rect">
            <a:avLst/>
          </a:prstGeom>
        </p:spPr>
        <p:txBody>
          <a:bodyPr vert="horz" lIns="36000" tIns="0" rIns="0" bIns="0" rtlCol="0">
            <a:noAutofit/>
          </a:bodyPr>
          <a:lstStyle>
            <a:lvl1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1pPr>
            <a:lvl2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2pPr>
            <a:lvl3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3pPr>
            <a:lvl4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4pPr>
            <a:lvl5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5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5-year PFS 88.7% (95% CI 85.3-92.1)</a:t>
            </a:r>
          </a:p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10-year PFS 79.7% (95% CI 74-85.5)</a:t>
            </a:r>
            <a:endParaRPr lang="en-US" sz="1000" dirty="0">
              <a:solidFill>
                <a:schemeClr val="accent2"/>
              </a:solidFill>
            </a:endParaRP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5-year PFS 86.1% (95% CI 76.4-95.8)</a:t>
            </a: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10-year PFS 86.1% (95% CI 76.4-95.8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None/>
            </a:pPr>
            <a:r>
              <a:rPr lang="de-DE" sz="1000" dirty="0">
                <a:solidFill>
                  <a:schemeClr val="tx1"/>
                </a:solidFill>
              </a:rPr>
              <a:t>HR = 0.8 (95% CI 0.4-1.4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Font typeface="Arial"/>
              <a:buNone/>
            </a:pPr>
            <a:endParaRPr lang="de-DE" sz="1000" dirty="0">
              <a:solidFill>
                <a:srgbClr val="0070C0"/>
              </a:solidFill>
            </a:endParaRPr>
          </a:p>
        </p:txBody>
      </p:sp>
      <p:pic>
        <p:nvPicPr>
          <p:cNvPr id="24" name="Grafik 23">
            <a:extLst>
              <a:ext uri="{FF2B5EF4-FFF2-40B4-BE49-F238E27FC236}">
                <a16:creationId xmlns:a16="http://schemas.microsoft.com/office/drawing/2014/main" id="{B8633783-F4A2-41CF-B78C-47D6CCC5ED2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5697" y="3729799"/>
            <a:ext cx="4844724" cy="3152265"/>
          </a:xfrm>
          <a:prstGeom prst="rect">
            <a:avLst/>
          </a:prstGeom>
        </p:spPr>
      </p:pic>
      <p:sp>
        <p:nvSpPr>
          <p:cNvPr id="25" name="Textplatzhalter 3">
            <a:extLst>
              <a:ext uri="{FF2B5EF4-FFF2-40B4-BE49-F238E27FC236}">
                <a16:creationId xmlns:a16="http://schemas.microsoft.com/office/drawing/2014/main" id="{A91C9EC0-0E21-44A0-9760-069AFA47D561}"/>
              </a:ext>
            </a:extLst>
          </p:cNvPr>
          <p:cNvSpPr txBox="1">
            <a:spLocks/>
          </p:cNvSpPr>
          <p:nvPr/>
        </p:nvSpPr>
        <p:spPr>
          <a:xfrm>
            <a:off x="7227333" y="4719986"/>
            <a:ext cx="3625152" cy="971204"/>
          </a:xfrm>
          <a:prstGeom prst="rect">
            <a:avLst/>
          </a:prstGeom>
        </p:spPr>
        <p:txBody>
          <a:bodyPr vert="horz" lIns="36000" tIns="0" rIns="0" bIns="0" rtlCol="0">
            <a:noAutofit/>
          </a:bodyPr>
          <a:lstStyle>
            <a:lvl1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1pPr>
            <a:lvl2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2pPr>
            <a:lvl3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3pPr>
            <a:lvl4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4pPr>
            <a:lvl5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5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5-year PFS 88.7% (95% CI 85.4-92.1)</a:t>
            </a:r>
          </a:p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10-year PFS 79.9% (95% CI 74.2-85.6)</a:t>
            </a:r>
            <a:endParaRPr lang="en-US" sz="1000" dirty="0">
              <a:solidFill>
                <a:schemeClr val="accent2"/>
              </a:solidFill>
            </a:endParaRP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5-year PFS 85.2% (95% CI 74.2-96.3)</a:t>
            </a: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10-year PFS 85.2% (95% CI 74.2-96.3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None/>
            </a:pPr>
            <a:r>
              <a:rPr lang="de-DE" sz="1000" dirty="0">
                <a:solidFill>
                  <a:schemeClr val="tx1"/>
                </a:solidFill>
              </a:rPr>
              <a:t>HR = 0.8 (95% CI 0.4-2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Font typeface="Arial"/>
              <a:buNone/>
            </a:pPr>
            <a:endParaRPr lang="de-DE" sz="1000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57590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7</Words>
  <Application>Microsoft Office PowerPoint</Application>
  <PresentationFormat>Breitbild</PresentationFormat>
  <Paragraphs>2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Supplemental Figure 1: Progression-free survival for all patients with early stages (A), for the comparison GP AB vs CDEF in early-stage patients (B), for the comparison GP ABC vs DEF in early-stage patients (C) and for the comparison GP ABCF vs DE in early-stage patients (D)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nis Eichenauer</dc:creator>
  <cp:lastModifiedBy>Dennis Eichenauer</cp:lastModifiedBy>
  <cp:revision>3</cp:revision>
  <dcterms:created xsi:type="dcterms:W3CDTF">2025-04-22T11:33:44Z</dcterms:created>
  <dcterms:modified xsi:type="dcterms:W3CDTF">2025-04-28T06:39:39Z</dcterms:modified>
</cp:coreProperties>
</file>